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wmf" ContentType="image/x-wmf"/>
  <Override PartName="/ppt/media/image8.png" ContentType="image/png"/>
  <Override PartName="/ppt/media/image9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D45FC-AD45-4443-A786-0F2E9B718F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0B28A-821F-4673-BDAA-4D176453ED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29B6D-1DC0-41B8-8AE3-324429F0FE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64817-0151-46F1-A170-B94DC7C2C3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57675-4530-42BC-A43A-4666B29AEB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19727-19C3-418E-B408-BBECCF538C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B5F35-16AE-4B9C-A694-C9F317FA09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95B85-3934-405A-BE5B-D2E98DA87C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575A6-7158-4D55-8049-BFB2BBD393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889F8-4D6F-4ACC-B869-48D0A3AFE6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99424-CE65-4912-91A5-3944515A2D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A49D19-8957-458F-907F-9929A79F8F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B4D828-EE0E-4C0B-9D7D-17617F5B72F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image" Target="../media/image3.png"/><Relationship Id="rId8" Type="http://schemas.openxmlformats.org/officeDocument/2006/relationships/image" Target="../media/image3.png"/><Relationship Id="rId9" Type="http://schemas.openxmlformats.org/officeDocument/2006/relationships/image" Target="../media/image3.png"/><Relationship Id="rId10" Type="http://schemas.openxmlformats.org/officeDocument/2006/relationships/image" Target="../media/image5.png"/><Relationship Id="rId11" Type="http://schemas.openxmlformats.org/officeDocument/2006/relationships/image" Target="../media/image5.png"/><Relationship Id="rId12" Type="http://schemas.openxmlformats.org/officeDocument/2006/relationships/image" Target="../media/image5.png"/><Relationship Id="rId13" Type="http://schemas.openxmlformats.org/officeDocument/2006/relationships/image" Target="../media/image6.png"/><Relationship Id="rId14" Type="http://schemas.openxmlformats.org/officeDocument/2006/relationships/oleObject" Target="../embeddings/oleObject1.bin"/><Relationship Id="rId15" Type="http://schemas.openxmlformats.org/officeDocument/2006/relationships/image" Target="../media/image7.wmf"/><Relationship Id="rId16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9.wmf"/><Relationship Id="rId4" Type="http://schemas.openxmlformats.org/officeDocument/2006/relationships/slideLayout" Target="../slideLayouts/slideLayout8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</a:rPr>
              <a:t>OSM 1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 Box 4"/>
          <p:cNvSpPr/>
          <p:nvPr/>
        </p:nvSpPr>
        <p:spPr>
          <a:xfrm>
            <a:off x="228600" y="380880"/>
            <a:ext cx="342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1A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883800" y="685800"/>
            <a:ext cx="6352560" cy="1982880"/>
            <a:chOff x="883800" y="685800"/>
            <a:chExt cx="6352560" cy="1982880"/>
          </a:xfrm>
        </p:grpSpPr>
        <p:pic>
          <p:nvPicPr>
            <p:cNvPr id="44" name="Straight Connector 126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1225440" y="1292040"/>
              <a:ext cx="5638320" cy="135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5" name=""/>
            <p:cNvGrpSpPr/>
            <p:nvPr/>
          </p:nvGrpSpPr>
          <p:grpSpPr>
            <a:xfrm>
              <a:off x="883800" y="685800"/>
              <a:ext cx="5979960" cy="1982880"/>
              <a:chOff x="883800" y="685800"/>
              <a:chExt cx="5979960" cy="1982880"/>
            </a:xfrm>
          </p:grpSpPr>
          <p:sp>
            <p:nvSpPr>
              <p:cNvPr id="46" name="TextBox 124"/>
              <p:cNvSpPr/>
              <p:nvPr/>
            </p:nvSpPr>
            <p:spPr>
              <a:xfrm>
                <a:off x="5797080" y="2209680"/>
                <a:ext cx="8938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73123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TaqI:G/A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47" name="Straight Arrow Connector 125"/>
              <p:cNvCxnSpPr/>
              <p:nvPr/>
            </p:nvCxnSpPr>
            <p:spPr>
              <a:xfrm flipH="1">
                <a:off x="6240960" y="1523520"/>
                <a:ext cx="1080" cy="68652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headEnd len="med" type="arrow" w="med"/>
              </a:ln>
            </p:spPr>
          </p:cxnSp>
          <p:pic>
            <p:nvPicPr>
              <p:cNvPr id="48" name="Rectangle 127" descr=""/>
              <p:cNvPicPr/>
              <p:nvPr/>
            </p:nvPicPr>
            <p:blipFill>
              <a:blip r:embed="rId2"/>
              <a:stretch/>
            </p:blipFill>
            <p:spPr>
              <a:xfrm>
                <a:off x="6186240" y="1199880"/>
                <a:ext cx="64116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Rectangle 128" descr=""/>
              <p:cNvPicPr/>
              <p:nvPr/>
            </p:nvPicPr>
            <p:blipFill>
              <a:blip r:embed="rId3"/>
              <a:stretch/>
            </p:blipFill>
            <p:spPr>
              <a:xfrm>
                <a:off x="593064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Rectangle 129" descr=""/>
              <p:cNvPicPr/>
              <p:nvPr/>
            </p:nvPicPr>
            <p:blipFill>
              <a:blip r:embed="rId4"/>
              <a:stretch/>
            </p:blipFill>
            <p:spPr>
              <a:xfrm>
                <a:off x="584028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Rectangle 130" descr=""/>
              <p:cNvPicPr/>
              <p:nvPr/>
            </p:nvPicPr>
            <p:blipFill>
              <a:blip r:embed="rId5"/>
              <a:stretch/>
            </p:blipFill>
            <p:spPr>
              <a:xfrm>
                <a:off x="5271840" y="1199880"/>
                <a:ext cx="7884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Rectangle 131" descr=""/>
              <p:cNvPicPr/>
              <p:nvPr/>
            </p:nvPicPr>
            <p:blipFill>
              <a:blip r:embed="rId6"/>
              <a:stretch/>
            </p:blipFill>
            <p:spPr>
              <a:xfrm>
                <a:off x="5119560" y="1199880"/>
                <a:ext cx="7884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Rectangle 132" descr=""/>
              <p:cNvPicPr/>
              <p:nvPr/>
            </p:nvPicPr>
            <p:blipFill>
              <a:blip r:embed="rId7"/>
              <a:stretch/>
            </p:blipFill>
            <p:spPr>
              <a:xfrm>
                <a:off x="504648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Rectangle 133" descr=""/>
              <p:cNvPicPr/>
              <p:nvPr/>
            </p:nvPicPr>
            <p:blipFill>
              <a:blip r:embed="rId8"/>
              <a:stretch/>
            </p:blipFill>
            <p:spPr>
              <a:xfrm>
                <a:off x="443664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Rectangle 134" descr=""/>
              <p:cNvPicPr/>
              <p:nvPr/>
            </p:nvPicPr>
            <p:blipFill>
              <a:blip r:embed="rId9"/>
              <a:stretch/>
            </p:blipFill>
            <p:spPr>
              <a:xfrm>
                <a:off x="352224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Rectangle 135" descr=""/>
              <p:cNvPicPr/>
              <p:nvPr/>
            </p:nvPicPr>
            <p:blipFill>
              <a:blip r:embed="rId10"/>
              <a:stretch/>
            </p:blipFill>
            <p:spPr>
              <a:xfrm>
                <a:off x="324936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Rectangle 136" descr=""/>
              <p:cNvPicPr/>
              <p:nvPr/>
            </p:nvPicPr>
            <p:blipFill>
              <a:blip r:embed="rId11"/>
              <a:stretch/>
            </p:blipFill>
            <p:spPr>
              <a:xfrm>
                <a:off x="245556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Rectangle 137" descr=""/>
              <p:cNvPicPr/>
              <p:nvPr/>
            </p:nvPicPr>
            <p:blipFill>
              <a:blip r:embed="rId12"/>
              <a:stretch/>
            </p:blipFill>
            <p:spPr>
              <a:xfrm>
                <a:off x="1541160" y="1199880"/>
                <a:ext cx="72720" cy="33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Rectangle 138" descr=""/>
              <p:cNvPicPr/>
              <p:nvPr/>
            </p:nvPicPr>
            <p:blipFill>
              <a:blip r:embed="rId13"/>
              <a:stretch/>
            </p:blipFill>
            <p:spPr>
              <a:xfrm>
                <a:off x="6338520" y="1199880"/>
                <a:ext cx="525240" cy="33660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60" name="Elbow Connector 139"/>
              <p:cNvCxnSpPr/>
              <p:nvPr/>
            </p:nvCxnSpPr>
            <p:spPr>
              <a:xfrm flipH="1" flipV="1" rot="5400000">
                <a:off x="5456520" y="1500480"/>
                <a:ext cx="686520" cy="732240"/>
              </a:xfrm>
              <a:prstGeom prst="bentConnector3">
                <a:avLst>
                  <a:gd name="adj1" fmla="val 38877"/>
                </a:avLst>
              </a:prstGeom>
              <a:ln w="1908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61" name="Elbow Connector 140"/>
              <p:cNvCxnSpPr/>
              <p:nvPr/>
            </p:nvCxnSpPr>
            <p:spPr>
              <a:xfrm flipH="1" flipV="1" rot="5400000">
                <a:off x="4983120" y="1180440"/>
                <a:ext cx="686520" cy="1371960"/>
              </a:xfrm>
              <a:prstGeom prst="bentConnector3">
                <a:avLst>
                  <a:gd name="adj1" fmla="val 50000"/>
                </a:avLst>
              </a:prstGeom>
              <a:ln w="1908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62" name="TextBox 141"/>
              <p:cNvSpPr/>
              <p:nvPr/>
            </p:nvSpPr>
            <p:spPr>
              <a:xfrm>
                <a:off x="4985280" y="2209680"/>
                <a:ext cx="9108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797523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ApAI:A/C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142"/>
              <p:cNvSpPr/>
              <p:nvPr/>
            </p:nvSpPr>
            <p:spPr>
              <a:xfrm>
                <a:off x="4206960" y="2209680"/>
                <a:ext cx="9352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15444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BsmI:G/A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4" name="Straight Arrow Connector 143"/>
              <p:cNvCxnSpPr/>
              <p:nvPr/>
            </p:nvCxnSpPr>
            <p:spPr>
              <a:xfrm flipH="1">
                <a:off x="1364400" y="1523520"/>
                <a:ext cx="1080" cy="68652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headEnd len="med" type="arrow" w="med"/>
              </a:ln>
            </p:spPr>
          </p:cxnSp>
          <p:sp>
            <p:nvSpPr>
              <p:cNvPr id="65" name="TextBox 144"/>
              <p:cNvSpPr/>
              <p:nvPr/>
            </p:nvSpPr>
            <p:spPr>
              <a:xfrm>
                <a:off x="883800" y="2209680"/>
                <a:ext cx="10022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115688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CdX-2:T/C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6" name="Straight Arrow Connector 145"/>
              <p:cNvCxnSpPr/>
              <p:nvPr/>
            </p:nvCxnSpPr>
            <p:spPr>
              <a:xfrm>
                <a:off x="4260600" y="838080"/>
                <a:ext cx="251496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prstDash val="dash"/>
                <a:miter/>
                <a:tailEnd len="med" type="arrow" w="med"/>
              </a:ln>
            </p:spPr>
          </p:cxnSp>
          <p:cxnSp>
            <p:nvCxnSpPr>
              <p:cNvPr id="67" name="Straight Arrow Connector 146"/>
              <p:cNvCxnSpPr/>
              <p:nvPr/>
            </p:nvCxnSpPr>
            <p:spPr>
              <a:xfrm>
                <a:off x="1517400" y="838080"/>
                <a:ext cx="2134080" cy="21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prstDash val="dash"/>
                <a:miter/>
                <a:headEnd len="med" type="arrow" w="med"/>
              </a:ln>
            </p:spPr>
          </p:cxnSp>
          <p:sp>
            <p:nvSpPr>
              <p:cNvPr id="68" name="TextBox 147"/>
              <p:cNvSpPr/>
              <p:nvPr/>
            </p:nvSpPr>
            <p:spPr>
              <a:xfrm>
                <a:off x="3667320" y="685800"/>
                <a:ext cx="586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63k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Box 148"/>
              <p:cNvSpPr/>
              <p:nvPr/>
            </p:nvSpPr>
            <p:spPr>
              <a:xfrm>
                <a:off x="903240" y="1143000"/>
                <a:ext cx="349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5’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0" name="TextBox 149"/>
            <p:cNvSpPr/>
            <p:nvPr/>
          </p:nvSpPr>
          <p:spPr>
            <a:xfrm>
              <a:off x="6886440" y="1143000"/>
              <a:ext cx="34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3’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71" name=""/>
          <p:cNvGraphicFramePr/>
          <p:nvPr/>
        </p:nvGraphicFramePr>
        <p:xfrm>
          <a:off x="152280" y="2743200"/>
          <a:ext cx="4570560" cy="1560240"/>
        </p:xfrm>
        <a:graphic>
          <a:graphicData uri="http://schemas.openxmlformats.org/drawingml/2006/table">
            <a:tbl>
              <a:tblPr/>
              <a:tblGrid>
                <a:gridCol w="422280"/>
                <a:gridCol w="998640"/>
                <a:gridCol w="858960"/>
                <a:gridCol w="787320"/>
                <a:gridCol w="787320"/>
                <a:gridCol w="716040"/>
              </a:tblGrid>
              <a:tr h="261360">
                <a:tc gridSpan="2"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DR SN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pri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136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15688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5444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797523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7312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360">
                <a:tc rowSpan="4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r>
                        <a:rPr b="1" lang="en-US" sz="11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15688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15444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797523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7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7312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7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4896000" y="2743200"/>
          <a:ext cx="3943080" cy="4091040"/>
        </p:xfrm>
        <a:graphic>
          <a:graphicData uri="http://schemas.openxmlformats.org/drawingml/2006/table">
            <a:tbl>
              <a:tblPr/>
              <a:tblGrid>
                <a:gridCol w="1295280"/>
                <a:gridCol w="785880"/>
                <a:gridCol w="971280"/>
                <a:gridCol w="890640"/>
              </a:tblGrid>
              <a:tr h="7030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HAP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any allele,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ree SN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smI/ApaI/Taq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n=70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L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two allele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smI/Taq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n=71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GCA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AG/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AAG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AA/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GAA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GG/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08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HAP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allelic copies of the haplotyp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smI/ApaI/Taq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cop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ne cop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wo copi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GCA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AAG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R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 GAA: b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73" name=""/>
          <p:cNvGrpSpPr/>
          <p:nvPr/>
        </p:nvGrpSpPr>
        <p:grpSpPr>
          <a:xfrm>
            <a:off x="609480" y="4267080"/>
            <a:ext cx="3962520" cy="2532240"/>
            <a:chOff x="609480" y="4267080"/>
            <a:chExt cx="3962520" cy="2532240"/>
          </a:xfrm>
        </p:grpSpPr>
        <p:graphicFrame>
          <p:nvGraphicFramePr>
            <p:cNvPr id="74" name=""/>
            <p:cNvGraphicFramePr/>
            <p:nvPr/>
          </p:nvGraphicFramePr>
          <p:xfrm>
            <a:off x="609480" y="4267080"/>
            <a:ext cx="3962520" cy="2362320"/>
          </p:xfrm>
          <a:graphic>
            <a:graphicData uri="http://schemas.openxmlformats.org/presentationml/2006/ole">
              <p:oleObj r:id="rId14" spid="">
                <p:embed/>
                <p:pic>
                  <p:nvPicPr>
                    <p:cNvPr id="75" name="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609480" y="4267080"/>
                      <a:ext cx="3962520" cy="2362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6" name=""/>
            <p:cNvSpPr/>
            <p:nvPr/>
          </p:nvSpPr>
          <p:spPr>
            <a:xfrm>
              <a:off x="1118520" y="655308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804320" y="653724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566080" y="653724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278880" y="655308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>
            <a:off x="443160" y="5164200"/>
            <a:ext cx="29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"/>
          <p:cNvGrpSpPr/>
          <p:nvPr/>
        </p:nvGrpSpPr>
        <p:grpSpPr>
          <a:xfrm>
            <a:off x="410040" y="334800"/>
            <a:ext cx="7360200" cy="1495800"/>
            <a:chOff x="410040" y="334800"/>
            <a:chExt cx="7360200" cy="1495800"/>
          </a:xfrm>
        </p:grpSpPr>
        <p:sp>
          <p:nvSpPr>
            <p:cNvPr id="82" name="TextBox 123"/>
            <p:cNvSpPr/>
            <p:nvPr/>
          </p:nvSpPr>
          <p:spPr>
            <a:xfrm>
              <a:off x="3614760" y="334800"/>
              <a:ext cx="703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35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" name=""/>
            <p:cNvGrpSpPr/>
            <p:nvPr/>
          </p:nvGrpSpPr>
          <p:grpSpPr>
            <a:xfrm>
              <a:off x="410040" y="486720"/>
              <a:ext cx="7360200" cy="1343880"/>
              <a:chOff x="410040" y="486720"/>
              <a:chExt cx="7360200" cy="1343880"/>
            </a:xfrm>
          </p:grpSpPr>
          <p:pic>
            <p:nvPicPr>
              <p:cNvPr id="84" name="Group 34" descr=""/>
              <p:cNvPicPr/>
              <p:nvPr/>
            </p:nvPicPr>
            <p:blipFill>
              <a:blip r:embed="rId1">
                <a:grayscl/>
              </a:blip>
              <a:stretch/>
            </p:blipFill>
            <p:spPr>
              <a:xfrm>
                <a:off x="782640" y="834840"/>
                <a:ext cx="6657840" cy="700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5" name="TextBox 118"/>
              <p:cNvSpPr/>
              <p:nvPr/>
            </p:nvSpPr>
            <p:spPr>
              <a:xfrm>
                <a:off x="432720" y="1554120"/>
                <a:ext cx="1211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3755166:G/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Box 119"/>
              <p:cNvSpPr/>
              <p:nvPr/>
            </p:nvSpPr>
            <p:spPr>
              <a:xfrm>
                <a:off x="4854240" y="1554120"/>
                <a:ext cx="1192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4668123:C/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Box 120"/>
              <p:cNvSpPr/>
              <p:nvPr/>
            </p:nvSpPr>
            <p:spPr>
              <a:xfrm>
                <a:off x="6005160" y="1554120"/>
                <a:ext cx="1192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s2075252:C/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88" name="Straight Arrow Connector 121"/>
              <p:cNvCxnSpPr/>
              <p:nvPr/>
            </p:nvCxnSpPr>
            <p:spPr>
              <a:xfrm>
                <a:off x="4376520" y="486720"/>
                <a:ext cx="3018600" cy="252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prstDash val="dash"/>
                <a:miter/>
                <a:tailEnd len="med" type="arrow" w="med"/>
              </a:ln>
            </p:spPr>
          </p:cxnSp>
          <p:cxnSp>
            <p:nvCxnSpPr>
              <p:cNvPr id="89" name="Straight Arrow Connector 122"/>
              <p:cNvCxnSpPr/>
              <p:nvPr/>
            </p:nvCxnSpPr>
            <p:spPr>
              <a:xfrm>
                <a:off x="917640" y="486720"/>
                <a:ext cx="2697480" cy="252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prstDash val="dash"/>
                <a:miter/>
                <a:headEnd len="med" type="arrow" w="med"/>
              </a:ln>
            </p:spPr>
          </p:cxnSp>
          <p:sp>
            <p:nvSpPr>
              <p:cNvPr id="90" name="TextBox 150"/>
              <p:cNvSpPr/>
              <p:nvPr/>
            </p:nvSpPr>
            <p:spPr>
              <a:xfrm>
                <a:off x="410040" y="792000"/>
                <a:ext cx="349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5’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151"/>
              <p:cNvSpPr/>
              <p:nvPr/>
            </p:nvSpPr>
            <p:spPr>
              <a:xfrm>
                <a:off x="7420320" y="834840"/>
                <a:ext cx="349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3’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2" name="Text Box 4"/>
          <p:cNvSpPr/>
          <p:nvPr/>
        </p:nvSpPr>
        <p:spPr>
          <a:xfrm>
            <a:off x="228600" y="144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1B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3" name=""/>
          <p:cNvGraphicFramePr/>
          <p:nvPr/>
        </p:nvGraphicFramePr>
        <p:xfrm>
          <a:off x="152280" y="1905120"/>
          <a:ext cx="4419720" cy="1676160"/>
        </p:xfrm>
        <a:graphic>
          <a:graphicData uri="http://schemas.openxmlformats.org/drawingml/2006/table">
            <a:tbl>
              <a:tblPr/>
              <a:tblGrid>
                <a:gridCol w="558720"/>
                <a:gridCol w="1204920"/>
                <a:gridCol w="825480"/>
                <a:gridCol w="884160"/>
                <a:gridCol w="946440"/>
              </a:tblGrid>
              <a:tr h="334800">
                <a:tc gridSpan="2" rowSpan="2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RP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pri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660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37551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46681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20752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3336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</a:t>
                      </a:r>
                      <a:r>
                        <a:rPr b="1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37551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36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46681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9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3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s20752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4" name=""/>
          <p:cNvGraphicFramePr/>
          <p:nvPr/>
        </p:nvGraphicFramePr>
        <p:xfrm>
          <a:off x="4724280" y="1905120"/>
          <a:ext cx="4267440" cy="5470560"/>
        </p:xfrm>
        <a:graphic>
          <a:graphicData uri="http://schemas.openxmlformats.org/drawingml/2006/table">
            <a:tbl>
              <a:tblPr/>
              <a:tblGrid>
                <a:gridCol w="1447920"/>
                <a:gridCol w="1128600"/>
                <a:gridCol w="730440"/>
                <a:gridCol w="274680"/>
                <a:gridCol w="685800"/>
              </a:tblGrid>
              <a:tr h="10076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HAP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any allele,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ree SN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s37551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rs46681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rs207525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n=70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L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two allele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s46681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n=71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n=71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AC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C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A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A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8: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08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PHAP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allelic copies of the haplotyp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rs3755166/rs4668123/rs207525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85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 cop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ne cop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wo copi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.9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.4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67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galin</a:t>
                      </a:r>
                      <a:r>
                        <a:rPr b="0" lang="en-US" sz="1000" spc="-1" strike="noStrike" baseline="-25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:G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682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grpSp>
        <p:nvGrpSpPr>
          <p:cNvPr id="95" name=""/>
          <p:cNvGrpSpPr/>
          <p:nvPr/>
        </p:nvGrpSpPr>
        <p:grpSpPr>
          <a:xfrm>
            <a:off x="495360" y="4227480"/>
            <a:ext cx="3238560" cy="2327400"/>
            <a:chOff x="495360" y="4227480"/>
            <a:chExt cx="3238560" cy="2327400"/>
          </a:xfrm>
        </p:grpSpPr>
        <p:graphicFrame>
          <p:nvGraphicFramePr>
            <p:cNvPr id="96" name=""/>
            <p:cNvGraphicFramePr/>
            <p:nvPr/>
          </p:nvGraphicFramePr>
          <p:xfrm>
            <a:off x="495360" y="4227480"/>
            <a:ext cx="3238560" cy="218736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97" name="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495360" y="4227480"/>
                      <a:ext cx="3238560" cy="2187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8" name=""/>
            <p:cNvSpPr/>
            <p:nvPr/>
          </p:nvSpPr>
          <p:spPr>
            <a:xfrm>
              <a:off x="1031040" y="630864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766160" y="630864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527920" y="630864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=7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314280" y="5029200"/>
            <a:ext cx="29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18:13:33Z</dcterms:created>
  <dc:creator>baydounm</dc:creator>
  <dc:description/>
  <dc:language>en-US</dc:language>
  <cp:lastModifiedBy>baydounm</cp:lastModifiedBy>
  <dcterms:modified xsi:type="dcterms:W3CDTF">2013-04-01T18:13:12Z</dcterms:modified>
  <cp:revision>95</cp:revision>
  <dc:subject/>
  <dc:title>Slide 1</dc:title>
</cp:coreProperties>
</file>